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  <p:sldId id="259" r:id="rId4"/>
    <p:sldId id="256" r:id="rId5"/>
    <p:sldId id="258" r:id="rId6"/>
    <p:sldId id="260" r:id="rId7"/>
    <p:sldId id="257" r:id="rId8"/>
  </p:sldIdLst>
  <p:sldSz cx="9144000" cy="6858000" type="screen4x3"/>
  <p:notesSz cx="6980238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4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-864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492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964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971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40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3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015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719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90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68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220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76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D2381-CE9C-426E-8550-A5848E923198}" type="datetimeFigureOut">
              <a:rPr lang="en-US" smtClean="0"/>
              <a:t>10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BD84C-97CA-4F7F-9896-7A88F7C4C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77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87680" y="517306"/>
            <a:ext cx="8314944" cy="49121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800"/>
              </a:spcAft>
            </a:pP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B Express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 AA9-LPMO containing a CBM1 domain in </a:t>
            </a:r>
            <a:r>
              <a:rPr lang="en-US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pergillus nidulans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 active on cellulose and cleaves cello-oligosaccharides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ru Jagadeeswaran, Lawrie Gainey, and Andrew J. Mort 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chemistry and Molecular Biology, Oklahoma State University, Stillwater, OK 74078, USA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rew J. Mort OCRID </a:t>
            </a:r>
            <a:r>
              <a:rPr lang="en-US" dirty="0">
                <a:solidFill>
                  <a:srgbClr val="0000EF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" panose="02020603050405020304" pitchFamily="18" charset="0"/>
              </a:rPr>
              <a:t>0000-0003-0051-2834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rew.mort@okstate.edu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ru Jagadeeswaran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ruswa@okstate.edu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wrie Gainey OCRID 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  <a:cs typeface="Consolas" panose="020B0609020204030204" pitchFamily="49" charset="0"/>
              </a:rPr>
              <a:t>0000-0001-7212-1133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wrie@okstate.edu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solidFill>
                  <a:srgbClr val="131413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4611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31648" y="698935"/>
            <a:ext cx="8607552" cy="59166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Table S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Amino-acid identities (%) of AN1602 with other LPMOs. Alignments were performed using </a:t>
            </a:r>
            <a:r>
              <a:rPr lang="en-US" sz="14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clustalW</a:t>
            </a:r>
            <a:r>
              <a:rPr lang="en-US" sz="14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using the catalytic domains of LPMO9s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Figure S1.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Identification of secreted protein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from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Pichia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culture media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a.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Protein elution profiles of AN1602 expressed in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P. pastori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uring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gel filtration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.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b.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Sequence of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identified protein using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orbitrap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mass spectrometry. Matched peptides observed in the spectrum are shown in yellow. Oxidized and alkylated residues are highlighted in green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c.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Predicted O-glycosylation sites (highlighted in green) in AN1602 from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tOGlyc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rver.</a:t>
            </a: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Figure S2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. Protein sequence of AN1602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b.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Modular organization of AN1602 showing signal peptide (SP), catalytic (AA9), linker and CBM1 domains; numbers represent amino acid residues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Figure S3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/MS spectra of oxidized product with m/z 543 that was further fragmented. Masses are labeled based on expected fragmentation from the C4 oxidized product oxidized Glc3.</a:t>
            </a: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Figure S4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ucture-guided homology model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Lucida Sans Unicode" panose="020B0602030504020204" pitchFamily="34" charset="0"/>
              </a:rPr>
              <a:t>of AN1602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btained from a structural overlay on the crystal structure of Ls(AA9)A (purple template, PDB code: 5ACF). </a:t>
            </a: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3969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9600776"/>
              </p:ext>
            </p:extLst>
          </p:nvPr>
        </p:nvGraphicFramePr>
        <p:xfrm>
          <a:off x="755650" y="561658"/>
          <a:ext cx="7632700" cy="2286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27100">
                  <a:extLst>
                    <a:ext uri="{9D8B030D-6E8A-4147-A177-3AD203B41FA5}">
                      <a16:colId xmlns="" xmlns:a16="http://schemas.microsoft.com/office/drawing/2014/main" val="3520312131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150977923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90186987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3368987083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310230515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3934027980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1786193927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2025954719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871120523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3688447353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2582924900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125729682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Cel61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TaGH61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AN1602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Ls_AA9_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cLPMO9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cLPMO9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cLPMO9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cLPMO9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PcGH61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TtGH61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cLPMO9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5094824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el61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6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4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3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2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9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9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6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8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9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8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8097578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aGH61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5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1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9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1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1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0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0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1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1721878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AN1602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51.1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3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7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8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8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5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8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5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1127745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Ls(AA9_A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100.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3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9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4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5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4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9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6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4693396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cLPMO9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7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8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9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8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3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0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460573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cLPMO9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57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9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4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1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0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1073227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cLPMO9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7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7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7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6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2290494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cLPMO9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3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3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8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1848771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cGH61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42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8491059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tGH61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00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74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4764081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cLPMO9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100.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14678914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8143875" y="6505575"/>
            <a:ext cx="7845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able S1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4697022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6775" y="6505575"/>
            <a:ext cx="606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ig S1</a:t>
            </a:r>
            <a:endParaRPr lang="en-US" sz="1400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2"/>
          <a:srcRect l="18291" t="64602" r="8191" b="15360"/>
          <a:stretch/>
        </p:blipFill>
        <p:spPr>
          <a:xfrm>
            <a:off x="1333197" y="3854327"/>
            <a:ext cx="6639228" cy="113096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02015" y="155673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704850" y="411431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3197" y="5320104"/>
            <a:ext cx="6639228" cy="102856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704850" y="557163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35" t="26291" r="14335" b="20118"/>
          <a:stretch/>
        </p:blipFill>
        <p:spPr>
          <a:xfrm>
            <a:off x="2778711" y="115410"/>
            <a:ext cx="3764132" cy="3675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46991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8143875" y="6505575"/>
            <a:ext cx="606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ig S2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4303650" y="374332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r="17412"/>
          <a:stretch/>
        </p:blipFill>
        <p:spPr>
          <a:xfrm>
            <a:off x="1877041" y="1120407"/>
            <a:ext cx="5561455" cy="1565643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2819399" y="4171950"/>
            <a:ext cx="3220950" cy="456575"/>
            <a:chOff x="2971800" y="2257425"/>
            <a:chExt cx="2968477" cy="456575"/>
          </a:xfrm>
        </p:grpSpPr>
        <p:sp>
          <p:nvSpPr>
            <p:cNvPr id="11" name="Rectangle 10"/>
            <p:cNvSpPr/>
            <p:nvPr/>
          </p:nvSpPr>
          <p:spPr>
            <a:xfrm>
              <a:off x="2990850" y="2514602"/>
              <a:ext cx="361950" cy="13334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3352801" y="2476502"/>
              <a:ext cx="1695450" cy="215445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053647" y="2552701"/>
              <a:ext cx="363316" cy="9525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23</a:t>
              </a:r>
              <a:endParaRPr lang="en-US" dirty="0"/>
            </a:p>
          </p:txBody>
        </p:sp>
        <p:sp>
          <p:nvSpPr>
            <p:cNvPr id="14" name="Rounded Rectangle 13"/>
            <p:cNvSpPr/>
            <p:nvPr/>
          </p:nvSpPr>
          <p:spPr>
            <a:xfrm>
              <a:off x="5438776" y="2495552"/>
              <a:ext cx="448302" cy="196395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053397" y="2305050"/>
              <a:ext cx="309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SP</a:t>
              </a:r>
              <a:endParaRPr lang="en-US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43350" y="2257425"/>
              <a:ext cx="3978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AA9</a:t>
              </a:r>
              <a:endParaRPr lang="en-US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19675" y="2352675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Linker</a:t>
              </a:r>
              <a:endParaRPr lang="en-US" sz="8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419725" y="2305050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BM1</a:t>
              </a:r>
              <a:endParaRPr lang="en-US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971800" y="2476503"/>
              <a:ext cx="433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1      18</a:t>
              </a:r>
              <a:endParaRPr lang="en-US" sz="8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324224" y="2486026"/>
              <a:ext cx="17570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19                                                                  234</a:t>
              </a:r>
              <a:endParaRPr lang="en-US" sz="8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991100" y="2498556"/>
              <a:ext cx="5148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35   318</a:t>
              </a:r>
              <a:endParaRPr lang="en-US" sz="8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383019" y="2486025"/>
              <a:ext cx="55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19     355</a:t>
              </a:r>
              <a:endParaRPr lang="en-US" sz="800" dirty="0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4303650" y="79057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83497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66" t="24445" r="16515"/>
          <a:stretch/>
        </p:blipFill>
        <p:spPr>
          <a:xfrm>
            <a:off x="1730510" y="2669455"/>
            <a:ext cx="5108440" cy="241546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359131" y="4408133"/>
            <a:ext cx="5368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07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5977849" y="3487487"/>
            <a:ext cx="461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25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1207484" y="3353454"/>
            <a:ext cx="890625" cy="1813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Relative abundance </a:t>
            </a:r>
            <a:endParaRPr lang="en-US" sz="1000" dirty="0"/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1730510" y="1943100"/>
            <a:ext cx="12982" cy="297713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996899" y="3268815"/>
            <a:ext cx="255319" cy="1995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70C0"/>
                </a:solidFill>
              </a:rPr>
              <a:t>B2</a:t>
            </a:r>
            <a:endParaRPr lang="en-US" sz="1200" dirty="0">
              <a:solidFill>
                <a:srgbClr val="0070C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5283001" y="4111284"/>
            <a:ext cx="463328" cy="204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70C0"/>
                </a:solidFill>
              </a:rPr>
              <a:t>B2-H</a:t>
            </a:r>
            <a:r>
              <a:rPr lang="en-US" sz="1200" baseline="-25000" dirty="0" smtClean="0">
                <a:solidFill>
                  <a:srgbClr val="0070C0"/>
                </a:solidFill>
              </a:rPr>
              <a:t>2</a:t>
            </a:r>
            <a:r>
              <a:rPr lang="en-US" sz="1200" dirty="0" smtClean="0">
                <a:solidFill>
                  <a:srgbClr val="0070C0"/>
                </a:solidFill>
              </a:rPr>
              <a:t>O</a:t>
            </a:r>
            <a:endParaRPr lang="en-US" sz="1200" dirty="0">
              <a:solidFill>
                <a:srgbClr val="0070C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372475" y="6467475"/>
            <a:ext cx="606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ig S3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6978619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8343900" y="6486525"/>
            <a:ext cx="606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ig S4</a:t>
            </a:r>
            <a:endParaRPr lang="en-US" sz="1400" dirty="0"/>
          </a:p>
        </p:txBody>
      </p:sp>
      <p:grpSp>
        <p:nvGrpSpPr>
          <p:cNvPr id="10" name="Group 9"/>
          <p:cNvGrpSpPr/>
          <p:nvPr/>
        </p:nvGrpSpPr>
        <p:grpSpPr>
          <a:xfrm>
            <a:off x="2952749" y="1693209"/>
            <a:ext cx="3236259" cy="3182470"/>
            <a:chOff x="2337816" y="1048512"/>
            <a:chExt cx="5233416" cy="5233416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37816" y="1048512"/>
              <a:ext cx="5233416" cy="523341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3364992" y="2157255"/>
              <a:ext cx="819669" cy="40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</a:rPr>
                <a:t>Asn70</a:t>
              </a:r>
              <a:endParaRPr lang="en-US" sz="1000" dirty="0">
                <a:solidFill>
                  <a:schemeClr val="bg1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155666" y="1952019"/>
              <a:ext cx="713386" cy="40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</a:rPr>
                <a:t>Ile79</a:t>
              </a:r>
              <a:endParaRPr lang="en-US" sz="1000" dirty="0">
                <a:solidFill>
                  <a:schemeClr val="bg1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86771" y="1517636"/>
              <a:ext cx="954466" cy="40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</a:rPr>
                <a:t>Loop L3</a:t>
              </a:r>
              <a:endParaRPr lang="en-US" sz="10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819401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33</TotalTime>
  <Words>375</Words>
  <Application>Microsoft Macintosh PowerPoint</Application>
  <PresentationFormat>On-screen Show (4:3)</PresentationFormat>
  <Paragraphs>141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indows 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ru</dc:creator>
  <cp:lastModifiedBy>Andrew Mort</cp:lastModifiedBy>
  <cp:revision>82</cp:revision>
  <cp:lastPrinted>2018-05-14T21:55:36Z</cp:lastPrinted>
  <dcterms:created xsi:type="dcterms:W3CDTF">2018-04-18T19:42:42Z</dcterms:created>
  <dcterms:modified xsi:type="dcterms:W3CDTF">2018-10-15T18:25:27Z</dcterms:modified>
</cp:coreProperties>
</file>